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8" d="100"/>
          <a:sy n="158" d="100"/>
        </p:scale>
        <p:origin x="-223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116632"/>
            <a:ext cx="914400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Figure 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2.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election of genes to study </a:t>
            </a:r>
            <a:r>
              <a:rPr lang="en-US" altLang="ru-RU" sz="12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PGP-containing peptides’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action under ischemia-reperfusion (IR) conditions based on our previous </a:t>
            </a:r>
            <a:r>
              <a:rPr lang="en-US" altLang="ru-RU" sz="12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results.</a:t>
            </a:r>
            <a:endParaRPr kumimoji="0" lang="ru-RU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14140" y="5744289"/>
            <a:ext cx="8915720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olcano plots illustrate the difference in mRNA expression between IS and IR groups revealed previously using RNA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ilippenko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., 2020) (a) and using RT-PCR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Dergunov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et al., 2021;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ilippenkov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et al., 2020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b). Up- and downregulated DEGs are represented as green and red dots, respectively (fold change &gt; 1.5,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&lt; 0.05 (a) and fold change &gt; 1.5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&lt; 0.05 (b)). Genes that were not differentially expressed (fold change ≤ 1.5;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≥ 0.05 (a); fold change ≤ 1.5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≥ 0.05 (b)) are represented as gray dots.</a:t>
            </a:r>
            <a:endParaRPr lang="ru-R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I:\Редактируемые\Для публикаций\0_текущие публикации\ПГП, ПГПЛ\вар2\fs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387" y="1052736"/>
            <a:ext cx="8165367" cy="37777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6396546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42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8</cp:revision>
  <dcterms:created xsi:type="dcterms:W3CDTF">2020-12-07T15:35:27Z</dcterms:created>
  <dcterms:modified xsi:type="dcterms:W3CDTF">2022-12-09T15:37:50Z</dcterms:modified>
</cp:coreProperties>
</file>